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1430000" cy="207645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D7561B-7D89-440C-A574-3B89D0037E8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971568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57160" y="12504600"/>
            <a:ext cx="971568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92498C-920A-42B4-BD90-15119361934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8359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57160" y="1250460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835960" y="1250460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57062DC-5B02-4CB0-96C6-AEC8B5C0A54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142160" y="599724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426800" y="599724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57160" y="1250460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142160" y="1250460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426800" y="12504600"/>
            <a:ext cx="312804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E958D-4A49-4F72-8152-B135754399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57160" y="5997240"/>
            <a:ext cx="9715680" cy="12458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426"/>
              </a:spcBef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538E42-FF08-4F72-90D3-179095F442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971568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5BA67A-9648-4E64-AB7C-FAF54E5B480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474120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835960" y="5997240"/>
            <a:ext cx="474120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986B24-5EFE-4E5F-B5CA-EBA5C5B03C0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B8D5C3-ADEB-40CA-9009-0E7FD7B2F04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57160" y="1844280"/>
            <a:ext cx="9715680" cy="160430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426"/>
              </a:spcBef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607C9-AABF-4528-B9C9-06E34FBD3B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835960" y="5997240"/>
            <a:ext cx="474120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57160" y="1250460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2733FF-D8D5-4007-9271-911387E5CD6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474120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8359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835960" y="1250460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C3C9B-AF3C-4E4A-B8CB-1F8ECF20384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571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835960" y="5997240"/>
            <a:ext cx="474120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57160" y="12504600"/>
            <a:ext cx="9715680" cy="5942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indent="0">
              <a:spcBef>
                <a:spcPts val="1426"/>
              </a:spcBef>
              <a:buNone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224C3A-59F5-41A6-A949-40049A86BD0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57160" y="1844280"/>
            <a:ext cx="9715680" cy="346068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ctr">
            <a:noAutofit/>
          </a:bodyPr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78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7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57160" y="5997240"/>
            <a:ext cx="9715680" cy="1245852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rmAutofit/>
          </a:bodyPr>
          <a:p>
            <a:pPr marL="608040" indent="-608040"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1" marL="1317600" indent="-506520"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2" marL="2027160" indent="-404640">
              <a:spcBef>
                <a:spcPts val="1426"/>
              </a:spcBef>
              <a:buClr>
                <a:srgbClr val="000000"/>
              </a:buClr>
              <a:buFont typeface="Times New Roman"/>
              <a:buChar char="•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3" marL="2838600" indent="-405000">
              <a:spcBef>
                <a:spcPts val="1426"/>
              </a:spcBef>
              <a:buClr>
                <a:srgbClr val="000000"/>
              </a:buClr>
              <a:buFont typeface="Times New Roman"/>
              <a:buChar char="–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4" marL="3649680" indent="-406440"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5" marL="3649680" indent="-406440"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  <a:p>
            <a:pPr lvl="6" marL="3649680" indent="-406440">
              <a:spcBef>
                <a:spcPts val="1426"/>
              </a:spcBef>
              <a:buClr>
                <a:srgbClr val="000000"/>
              </a:buClr>
              <a:buFont typeface="Times New Roman"/>
              <a:buChar char="»"/>
              <a:tabLst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57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57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56800" y="18919440"/>
            <a:ext cx="2381400" cy="138420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Autofit/>
          </a:bodyPr>
          <a:lstStyle>
            <a:lvl1pPr indent="0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  <a:defRPr b="0" lang="en-US" sz="2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905280" y="18919440"/>
            <a:ext cx="3619440" cy="138420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Autofit/>
          </a:bodyPr>
          <a:lstStyle>
            <a:lvl1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  <a:defRPr b="0" lang="en-US" sz="2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r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191080" y="18919440"/>
            <a:ext cx="2381400" cy="1384200"/>
          </a:xfrm>
          <a:prstGeom prst="rect">
            <a:avLst/>
          </a:prstGeom>
          <a:noFill/>
          <a:ln w="0">
            <a:noFill/>
          </a:ln>
        </p:spPr>
        <p:txBody>
          <a:bodyPr lIns="162360" rIns="162360" tIns="81000" bIns="81000" anchor="t">
            <a:noAutofit/>
          </a:bodyPr>
          <a:lstStyle>
            <a:lvl1pPr indent="0" algn="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  <a:defRPr b="0" lang="en-US" sz="25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1622520"/>
                <a:tab algn="l" pos="3244680"/>
                <a:tab algn="l" pos="4867200"/>
                <a:tab algn="l" pos="6489720"/>
                <a:tab algn="l" pos="8112240"/>
                <a:tab algn="l" pos="9734400"/>
              </a:tabLst>
            </a:pPr>
            <a:fld id="{C4AD7959-52B8-433E-B2D2-1D70DF89B4AF}" type="slidenum">
              <a:rPr b="0" lang="en-US" sz="25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25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Fly%20subsection%20dotplot" descr=""/>
          <p:cNvPicPr/>
          <p:nvPr/>
        </p:nvPicPr>
        <p:blipFill>
          <a:blip r:embed="rId1"/>
          <a:stretch/>
        </p:blipFill>
        <p:spPr>
          <a:xfrm>
            <a:off x="436680" y="442800"/>
            <a:ext cx="8078760" cy="1592892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7977240" y="403200"/>
            <a:ext cx="780840" cy="16057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8053560" y="1023840"/>
            <a:ext cx="188640" cy="1569960"/>
          </a:xfrm>
          <a:custGeom>
            <a:avLst/>
            <a:gdLst>
              <a:gd name="textAreaLeft" fmla="*/ 0 w 188640"/>
              <a:gd name="textAreaRight" fmla="*/ 68040 w 188640"/>
              <a:gd name="textAreaTop" fmla="*/ 40680 h 1569960"/>
              <a:gd name="textAreaBottom" fmla="*/ 1529280 h 1569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8062920" y="2604960"/>
            <a:ext cx="179280" cy="723960"/>
          </a:xfrm>
          <a:custGeom>
            <a:avLst/>
            <a:gdLst>
              <a:gd name="textAreaLeft" fmla="*/ 0 w 179280"/>
              <a:gd name="textAreaRight" fmla="*/ 64800 w 179280"/>
              <a:gd name="textAreaTop" fmla="*/ 18720 h 723960"/>
              <a:gd name="textAreaBottom" fmla="*/ 705240 h 723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204840" y="406440"/>
            <a:ext cx="780840" cy="16057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357120" y="558720"/>
            <a:ext cx="8124840" cy="43344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 rot="16200000">
            <a:off x="1763640" y="15480"/>
            <a:ext cx="179640" cy="1684440"/>
          </a:xfrm>
          <a:custGeom>
            <a:avLst/>
            <a:gdLst>
              <a:gd name="textAreaLeft" fmla="*/ 0 w 179640"/>
              <a:gd name="textAreaRight" fmla="*/ 64800 w 179640"/>
              <a:gd name="textAreaTop" fmla="*/ 43920 h 1684440"/>
              <a:gd name="textAreaBottom" fmla="*/ 1640520 h 168444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 rot="16200000">
            <a:off x="7273800" y="296640"/>
            <a:ext cx="179640" cy="1122120"/>
          </a:xfrm>
          <a:custGeom>
            <a:avLst/>
            <a:gdLst>
              <a:gd name="textAreaLeft" fmla="*/ 0 w 179640"/>
              <a:gd name="textAreaRight" fmla="*/ 64800 w 179640"/>
              <a:gd name="textAreaTop" fmla="*/ 29160 h 1122120"/>
              <a:gd name="textAreaBottom" fmla="*/ 1092960 h 112212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 rot="16200000">
            <a:off x="4647240" y="-1159560"/>
            <a:ext cx="188640" cy="4048200"/>
          </a:xfrm>
          <a:custGeom>
            <a:avLst/>
            <a:gdLst>
              <a:gd name="textAreaLeft" fmla="*/ 0 w 188640"/>
              <a:gd name="textAreaRight" fmla="*/ 68040 w 188640"/>
              <a:gd name="textAreaTop" fmla="*/ 105480 h 4048200"/>
              <a:gd name="textAreaBottom" fmla="*/ 3942720 h 404820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8062920" y="3348000"/>
            <a:ext cx="179280" cy="561960"/>
          </a:xfrm>
          <a:custGeom>
            <a:avLst/>
            <a:gdLst>
              <a:gd name="textAreaLeft" fmla="*/ 0 w 179280"/>
              <a:gd name="textAreaRight" fmla="*/ 64800 w 179280"/>
              <a:gd name="textAreaTop" fmla="*/ 14400 h 561960"/>
              <a:gd name="textAreaBottom" fmla="*/ 547560 h 561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8062920" y="4538520"/>
            <a:ext cx="179280" cy="1122480"/>
          </a:xfrm>
          <a:custGeom>
            <a:avLst/>
            <a:gdLst>
              <a:gd name="textAreaLeft" fmla="*/ 0 w 179280"/>
              <a:gd name="textAreaRight" fmla="*/ 64800 w 179280"/>
              <a:gd name="textAreaTop" fmla="*/ 29160 h 1122480"/>
              <a:gd name="textAreaBottom" fmla="*/ 1093320 h 1122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8062920" y="3919680"/>
            <a:ext cx="179280" cy="588960"/>
          </a:xfrm>
          <a:custGeom>
            <a:avLst/>
            <a:gdLst>
              <a:gd name="textAreaLeft" fmla="*/ 0 w 179280"/>
              <a:gd name="textAreaRight" fmla="*/ 64800 w 179280"/>
              <a:gd name="textAreaTop" fmla="*/ 15120 h 588960"/>
              <a:gd name="textAreaBottom" fmla="*/ 573840 h 58896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8062920" y="5681520"/>
            <a:ext cx="179280" cy="1122480"/>
          </a:xfrm>
          <a:custGeom>
            <a:avLst/>
            <a:gdLst>
              <a:gd name="textAreaLeft" fmla="*/ 0 w 179280"/>
              <a:gd name="textAreaRight" fmla="*/ 64800 w 179280"/>
              <a:gd name="textAreaTop" fmla="*/ 29160 h 1122480"/>
              <a:gd name="textAreaBottom" fmla="*/ 1093320 h 1122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8062920" y="6815160"/>
            <a:ext cx="179280" cy="8961480"/>
          </a:xfrm>
          <a:custGeom>
            <a:avLst/>
            <a:gdLst>
              <a:gd name="textAreaLeft" fmla="*/ 0 w 179280"/>
              <a:gd name="textAreaRight" fmla="*/ 64800 w 179280"/>
              <a:gd name="textAreaTop" fmla="*/ 233640 h 8961480"/>
              <a:gd name="textAreaBottom" fmla="*/ 8727840 h 8961480"/>
            </a:gdLst>
            <a:ahLst/>
            <a:rect l="textAreaLeft" t="textAreaTop" r="textAreaRight" b="textAreaBottom"/>
            <a:pathLst>
              <a:path w="21600" h="21600">
                <a:moveTo>
                  <a:pt x="0" y="0"/>
                </a:moveTo>
                <a:cubicBezTo>
                  <a:pt x="5400" y="0"/>
                  <a:pt x="10800" y="900"/>
                  <a:pt x="10800" y="1800"/>
                </a:cubicBezTo>
                <a:lnTo>
                  <a:pt x="10800" y="9000"/>
                </a:lnTo>
                <a:cubicBezTo>
                  <a:pt x="10800" y="9900"/>
                  <a:pt x="16200" y="10800"/>
                  <a:pt x="21600" y="10800"/>
                </a:cubicBezTo>
                <a:cubicBezTo>
                  <a:pt x="16200" y="10800"/>
                  <a:pt x="10800" y="11700"/>
                  <a:pt x="10800" y="12600"/>
                </a:cubicBezTo>
                <a:lnTo>
                  <a:pt x="10800" y="19800"/>
                </a:lnTo>
                <a:cubicBezTo>
                  <a:pt x="10800" y="20700"/>
                  <a:pt x="5400" y="21600"/>
                  <a:pt x="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3476520" y="41400"/>
            <a:ext cx="253368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reference locu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1209600" y="157320"/>
            <a:ext cx="14097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6k upstream</a:t>
            </a:r>
            <a:br>
              <a:rPr sz="1800"/>
            </a:b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of Orly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515280" y="176040"/>
            <a:ext cx="17809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4k downstream</a:t>
            </a:r>
            <a:br>
              <a:rPr sz="1800"/>
            </a:b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of Orly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8115480" y="1481040"/>
            <a:ext cx="1533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6k upstream</a:t>
            </a:r>
            <a:br>
              <a:rPr sz="1800"/>
            </a:b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of Ssty1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8163000" y="2757600"/>
            <a:ext cx="2819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Ssty1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reference locu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7696080" y="3767040"/>
            <a:ext cx="2819520" cy="82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Asty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reference </a:t>
            </a:r>
            <a:br>
              <a:rPr sz="2400"/>
            </a:b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locus (partial)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8172360" y="3433680"/>
            <a:ext cx="2057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2k upstream of Asty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8153280" y="4910040"/>
            <a:ext cx="2371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4k downstream of Asty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1000080" y="3338640"/>
            <a:ext cx="10077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1009800" y="5681520"/>
            <a:ext cx="1007748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8153280" y="6043680"/>
            <a:ext cx="1971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125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1800" spc="-1" strike="noStrike">
                <a:solidFill>
                  <a:srgbClr val="000000"/>
                </a:solidFill>
                <a:latin typeface="Times New Roman"/>
              </a:rPr>
              <a:t>4k upstream of Sly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8058240" y="11072880"/>
            <a:ext cx="281916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4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US" sz="2400" spc="-1" strike="noStrike">
                <a:solidFill>
                  <a:srgbClr val="000000"/>
                </a:solidFill>
                <a:latin typeface="Times New Roman"/>
              </a:rPr>
              <a:t> reference locus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694240" y="2602800"/>
            <a:ext cx="28440" cy="28440"/>
          </a:xfrm>
          <a:prstGeom prst="line">
            <a:avLst/>
          </a:prstGeom>
          <a:ln w="63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2755800" y="2665080"/>
            <a:ext cx="35640" cy="35640"/>
          </a:xfrm>
          <a:prstGeom prst="line">
            <a:avLst/>
          </a:prstGeom>
          <a:ln w="63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160" bIns="-11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3183840" y="3083760"/>
            <a:ext cx="188640" cy="188640"/>
          </a:xfrm>
          <a:prstGeom prst="line">
            <a:avLst/>
          </a:prstGeom>
          <a:ln w="63360">
            <a:solidFill>
              <a:srgbClr val="008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3490560" y="4038120"/>
            <a:ext cx="35640" cy="35640"/>
          </a:xfrm>
          <a:prstGeom prst="line">
            <a:avLst/>
          </a:prstGeom>
          <a:ln w="63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1160" bIns="-111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3742920" y="4290480"/>
            <a:ext cx="36000" cy="36000"/>
          </a:xfrm>
          <a:prstGeom prst="line">
            <a:avLst/>
          </a:prstGeom>
          <a:ln w="63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0800" bIns="-10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3932640" y="4469760"/>
            <a:ext cx="12240" cy="12240"/>
          </a:xfrm>
          <a:prstGeom prst="line">
            <a:avLst/>
          </a:prstGeom>
          <a:ln w="63360">
            <a:solidFill>
              <a:srgbClr val="3333cc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560" bIns="-345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 flipH="1">
            <a:off x="5256720" y="8347320"/>
            <a:ext cx="28440" cy="28440"/>
          </a:xfrm>
          <a:prstGeom prst="line">
            <a:avLst/>
          </a:prstGeom>
          <a:ln w="633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 flipH="1">
            <a:off x="5374080" y="8079120"/>
            <a:ext cx="170640" cy="170640"/>
          </a:xfrm>
          <a:prstGeom prst="line">
            <a:avLst/>
          </a:prstGeom>
          <a:ln w="63360">
            <a:solidFill>
              <a:srgbClr val="ff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 flipH="1">
            <a:off x="6859080" y="6842520"/>
            <a:ext cx="28080" cy="28080"/>
          </a:xfrm>
          <a:prstGeom prst="line">
            <a:avLst/>
          </a:prstGeom>
          <a:ln w="633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720" bIns="-187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 flipH="1">
            <a:off x="6496560" y="7226640"/>
            <a:ext cx="28440" cy="28440"/>
          </a:xfrm>
          <a:prstGeom prst="line">
            <a:avLst/>
          </a:prstGeom>
          <a:ln w="63360">
            <a:solidFill>
              <a:srgbClr val="8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8360" bIns="-1836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3000240" y="2462040"/>
            <a:ext cx="1933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2000" spc="-1" strike="noStrike">
                <a:solidFill>
                  <a:srgbClr val="008000"/>
                </a:solidFill>
                <a:latin typeface="Times New Roman"/>
              </a:rPr>
              <a:t>Ssty1 </a:t>
            </a:r>
            <a:r>
              <a:rPr b="1" lang="en-GB" sz="2000" spc="-1" strike="noStrike">
                <a:solidFill>
                  <a:srgbClr val="008000"/>
                </a:solidFill>
                <a:latin typeface="Times New Roman"/>
              </a:rPr>
              <a:t>exons 1-3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3724200" y="3871800"/>
            <a:ext cx="1933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2000" spc="-1" strike="noStrike">
                <a:solidFill>
                  <a:srgbClr val="3333cc"/>
                </a:solidFill>
                <a:latin typeface="Times New Roman"/>
              </a:rPr>
              <a:t>Asty</a:t>
            </a:r>
            <a:r>
              <a:rPr b="1" lang="en-GB" sz="2000" spc="-1" strike="noStrike">
                <a:solidFill>
                  <a:srgbClr val="3333cc"/>
                </a:solidFill>
                <a:latin typeface="Times New Roman"/>
              </a:rPr>
              <a:t> exons 2-4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3886200" y="7348680"/>
            <a:ext cx="1933560" cy="1008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2000" spc="-1" strike="noStrike">
                <a:solidFill>
                  <a:srgbClr val="ff00ff"/>
                </a:solidFill>
                <a:latin typeface="Times New Roman"/>
              </a:rPr>
              <a:t>Novel exons  antisense to </a:t>
            </a:r>
            <a:r>
              <a:rPr b="1" i="1" lang="en-GB" sz="2000" spc="-1" strike="noStrike">
                <a:solidFill>
                  <a:srgbClr val="ff00ff"/>
                </a:solidFill>
                <a:latin typeface="Times New Roman"/>
              </a:rPr>
              <a:t>Sly</a:t>
            </a:r>
            <a:br>
              <a:rPr sz="2000"/>
            </a:br>
            <a:r>
              <a:rPr b="1" lang="en-GB" sz="2000" spc="-1" strike="noStrike">
                <a:solidFill>
                  <a:srgbClr val="ff00ff"/>
                </a:solidFill>
                <a:latin typeface="Times New Roman"/>
              </a:rPr>
              <a:t>intron 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6505560" y="6872400"/>
            <a:ext cx="1933560" cy="70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25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GB" sz="2000" spc="-1" strike="noStrike">
                <a:solidFill>
                  <a:srgbClr val="993366"/>
                </a:solidFill>
                <a:latin typeface="Times New Roman"/>
              </a:rPr>
              <a:t>      </a:t>
            </a:r>
            <a:r>
              <a:rPr b="1" i="1" lang="en-GB" sz="2000" spc="-1" strike="noStrike">
                <a:solidFill>
                  <a:srgbClr val="993366"/>
                </a:solidFill>
                <a:latin typeface="Times New Roman"/>
              </a:rPr>
              <a:t>Sly </a:t>
            </a:r>
            <a:br>
              <a:rPr sz="2000"/>
            </a:br>
            <a:r>
              <a:rPr b="1" lang="en-GB" sz="2000" spc="-1" strike="noStrike">
                <a:solidFill>
                  <a:srgbClr val="993366"/>
                </a:solidFill>
                <a:latin typeface="Times New Roman"/>
              </a:rPr>
              <a:t>exons 1-2</a:t>
            </a:r>
            <a:endParaRPr b="0" lang="en-US" sz="2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0" y="16022520"/>
            <a:ext cx="11430000" cy="4322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marL="457200" indent="-457200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    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Dotter alignment showing the homologies between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and its constituent loci.  Exon locations of the constituent loci are indicated, as are the novel exons contained in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 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transcripts. 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has three distinct regions of high sequence similarity: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spcBef>
                <a:spcPts val="1500"/>
              </a:spcBef>
              <a:buClr>
                <a:srgbClr val="000000"/>
              </a:buClr>
              <a:buFont typeface="Times New Roman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The 5’ end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is similar to exons 1-3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Ssty1 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(indicated in green), and this similarity extends ~6k into the upstream promoter reg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spcBef>
                <a:spcPts val="1500"/>
              </a:spcBef>
              <a:buClr>
                <a:srgbClr val="000000"/>
              </a:buClr>
              <a:buFont typeface="Times New Roman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The central portion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is similar to exons 2-4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Asty 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(indicated in blue), and ~3k of flanking downstream sequence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  <a:p>
            <a:pPr marL="457200" indent="-457200">
              <a:spcBef>
                <a:spcPts val="1500"/>
              </a:spcBef>
              <a:buClr>
                <a:srgbClr val="000000"/>
              </a:buClr>
              <a:buFont typeface="Times New Roman"/>
              <a:buAutoNum type="arabicParenR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The 3’ portion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is similar to exons 1-2 (and partial intron 2)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 (indicated in purple), in antisense orientation.  The ~4k of sequence downstream from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 Or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matches the sequence upstream of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, indicating retention of a relict </a:t>
            </a:r>
            <a:r>
              <a:rPr b="0" i="1" lang="en-GB" sz="2400" spc="-1" strike="noStrike">
                <a:solidFill>
                  <a:srgbClr val="000000"/>
                </a:solidFill>
                <a:latin typeface="Times New Roman"/>
              </a:rPr>
              <a:t>Sly</a:t>
            </a:r>
            <a:r>
              <a:rPr b="0" lang="en-GB" sz="2400" spc="-1" strike="noStrike">
                <a:solidFill>
                  <a:srgbClr val="000000"/>
                </a:solidFill>
                <a:latin typeface="Times New Roman"/>
              </a:rPr>
              <a:t> promoter region</a:t>
            </a:r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7-02-19T13:55:22Z</dcterms:created>
  <dc:creator>pjie2b</dc:creator>
  <dc:description/>
  <dc:language>en-US</dc:language>
  <cp:lastModifiedBy>pjie2b</cp:lastModifiedBy>
  <dcterms:modified xsi:type="dcterms:W3CDTF">2007-09-20T14:28:39Z</dcterms:modified>
  <cp:revision>5</cp:revision>
  <dc:subject/>
  <dc:title>PowerPoint Presentation</dc:title>
</cp:coreProperties>
</file>